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5169" autoAdjust="0"/>
  </p:normalViewPr>
  <p:slideViewPr>
    <p:cSldViewPr snapToGrid="0">
      <p:cViewPr varScale="1">
        <p:scale>
          <a:sx n="68" d="100"/>
          <a:sy n="68" d="100"/>
        </p:scale>
        <p:origin x="81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123902-A373-4CC7-9E74-C055213BDD96}" type="datetimeFigureOut">
              <a:rPr lang="en-GB" smtClean="0"/>
              <a:t>13/01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B760F1-7E9C-4B71-BFBF-DFA5CDF649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2466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B760F1-7E9C-4B71-BFBF-DFA5CDF6499D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84297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0CFB68-63B7-49B1-A94B-C641DCAA38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8E25F0A-6DE9-457B-B44A-06A2F6F30CA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52EFF3-A0E2-4448-9AE0-EA4F993D87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B3EE3-8928-4443-B767-BDE66D5B75ED}" type="datetimeFigureOut">
              <a:rPr lang="en-US" smtClean="0"/>
              <a:t>1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8A51EC-5221-4D7C-A3FB-5F169782DB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1CD87A-19C3-4681-B2CE-E672CF3336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A421D-0475-4BC4-82A6-76E80ED3E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770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27F142-AB03-4EFA-AC45-7F51F67713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0639F9A-AF6E-467E-BAC3-D0E6F7A12D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837BF2-021C-4D27-9FCC-CE6769D8C3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B3EE3-8928-4443-B767-BDE66D5B75ED}" type="datetimeFigureOut">
              <a:rPr lang="en-US" smtClean="0"/>
              <a:t>1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F82E40-58C4-4153-A715-EECC8699F0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9AA764-D55D-46F5-9EAA-48E1935A10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A421D-0475-4BC4-82A6-76E80ED3E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3605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153B176-8FE7-48E9-A302-ABB5289CAF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C51E270-5D7A-4CA3-AEEE-2147F8FAF5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692A05-AEBE-47B5-A3B4-89E1590F2D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B3EE3-8928-4443-B767-BDE66D5B75ED}" type="datetimeFigureOut">
              <a:rPr lang="en-US" smtClean="0"/>
              <a:t>1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C7F3EA-25E2-4374-9C51-492ACCD4D1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2100D0-3371-47E8-8CB9-80CCEE97F6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A421D-0475-4BC4-82A6-76E80ED3E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698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51A8BB-F85D-4D91-892E-87B2AB57F3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8EAD50-01BF-4040-BDD5-5940915EB4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F7CE07-E059-4786-8F35-1B4B8D088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B3EE3-8928-4443-B767-BDE66D5B75ED}" type="datetimeFigureOut">
              <a:rPr lang="en-US" smtClean="0"/>
              <a:t>1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5E23F6-7143-42CD-A86B-56CE2EF3FA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8F2D87-86FB-4D90-96F3-F2C0FB094A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A421D-0475-4BC4-82A6-76E80ED3E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32799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58A78E-56A9-4D47-A7C2-0076BC5CDB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7B5187-361C-4776-B1DC-801E346325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A4ABEB-482A-4C83-BA38-8CA59CD3DB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B3EE3-8928-4443-B767-BDE66D5B75ED}" type="datetimeFigureOut">
              <a:rPr lang="en-US" smtClean="0"/>
              <a:t>1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11D6E6-8B70-47E9-9442-D4CB2E2495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2253F4-79D5-47E2-AC55-1B447D20D3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A421D-0475-4BC4-82A6-76E80ED3E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04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404E56-0E97-4C90-9FB0-CB30F7137C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9925A0-08EA-4311-AE8E-B22903EBDF9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6AF312-1B20-4947-800E-C4D0FF1014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D19C4F-D717-46F6-96CB-B5651533D6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B3EE3-8928-4443-B767-BDE66D5B75ED}" type="datetimeFigureOut">
              <a:rPr lang="en-US" smtClean="0"/>
              <a:t>1/1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1FBD10-DF78-4B5D-90BC-8481EF63B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9FE1853-916E-4AAE-B47E-47F564C036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A421D-0475-4BC4-82A6-76E80ED3E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00424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A6974E-3580-4AEA-8507-7365E6C5E6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9B43DE-6153-4D2F-B1CF-283C172AE4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BAEFF86-E43D-42BA-A334-AB45452CB7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8FDEBAD-1F44-4451-9EC2-DC70146E80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3B85ECA-17B0-45FA-A178-3987EBA6C27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736A864-98B3-4CDA-851B-04DD8D60BD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B3EE3-8928-4443-B767-BDE66D5B75ED}" type="datetimeFigureOut">
              <a:rPr lang="en-US" smtClean="0"/>
              <a:t>1/13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84B323C-B291-4D0E-811E-82708E084E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30DC36C-B4CD-4742-B86F-A0DA78EC72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A421D-0475-4BC4-82A6-76E80ED3E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242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AA8A4B-0753-4EEB-A48A-9B5BB9769F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ACE7E45-6496-490A-9044-C4EE4FE8A9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B3EE3-8928-4443-B767-BDE66D5B75ED}" type="datetimeFigureOut">
              <a:rPr lang="en-US" smtClean="0"/>
              <a:t>1/13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BDB973E-6E9E-4A72-A31B-B7B16B3EE5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0E1D8C5-C5E4-4675-AD58-886B010980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A421D-0475-4BC4-82A6-76E80ED3E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4458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435A25D-B660-4C2F-BA12-4D24CA6E90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B3EE3-8928-4443-B767-BDE66D5B75ED}" type="datetimeFigureOut">
              <a:rPr lang="en-US" smtClean="0"/>
              <a:t>1/13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270A67D-23C0-41E4-9221-8879AAC645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412EAA8-29F2-4A15-9268-2D16D7CC44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A421D-0475-4BC4-82A6-76E80ED3E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5315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DBC74D-AB27-4234-AEEC-7F1E689A5D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D00E1D-C0E1-4043-99FC-CA659FEFD47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9CA6043-165F-4525-AA40-B3E214DDA4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C2FD51-40C9-42FE-B923-4ABAD129A4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B3EE3-8928-4443-B767-BDE66D5B75ED}" type="datetimeFigureOut">
              <a:rPr lang="en-US" smtClean="0"/>
              <a:t>1/1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587FB6-847B-4247-AA70-E5FE187985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4D46EE-82BE-4821-88B9-20FF0BAAA6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A421D-0475-4BC4-82A6-76E80ED3E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8125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53C2F0-45DC-4BBF-B245-097BE6F95A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6781D9A-7D4C-409D-A41E-EE96BD64C2C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A9E8C64-177A-4D6A-889F-062BBA2793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FFE7FA-0EA0-4C67-9361-0491D4C644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B3EE3-8928-4443-B767-BDE66D5B75ED}" type="datetimeFigureOut">
              <a:rPr lang="en-US" smtClean="0"/>
              <a:t>1/1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2F7A8D-2FD5-4131-8340-16CBE46BB0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8B788F-A97F-4AFA-BD75-7FE865C07B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A421D-0475-4BC4-82A6-76E80ED3E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06494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9210BCE-192E-46FE-96C4-98B4CBEB0C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FDA8E9-D3B4-44A8-BC3D-F3CBBACD70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F8DF28-9508-4810-A5EB-A3D32D614BB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DB3EE3-8928-4443-B767-BDE66D5B75ED}" type="datetimeFigureOut">
              <a:rPr lang="en-US" smtClean="0"/>
              <a:t>1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9F215D-A3C1-4059-9CEF-F57755CDB71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3F921D-8AC8-4E15-9B54-9B780560050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1A421D-0475-4BC4-82A6-76E80ED3E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5745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Drawing 0">
            <a:extLst>
              <a:ext uri="{FF2B5EF4-FFF2-40B4-BE49-F238E27FC236}">
                <a16:creationId xmlns:a16="http://schemas.microsoft.com/office/drawing/2014/main" id="{D536EED8-79A4-499E-9C61-A7C8EED01C8A}"/>
              </a:ext>
            </a:extLst>
          </p:cNvPr>
          <p:cNvPicPr/>
          <p:nvPr/>
        </p:nvPicPr>
        <p:blipFill rotWithShape="1">
          <a:blip r:embed="rId3"/>
          <a:srcRect r="29242" b="31625"/>
          <a:stretch/>
        </p:blipFill>
        <p:spPr bwMode="auto">
          <a:xfrm>
            <a:off x="1484050" y="967666"/>
            <a:ext cx="9223899" cy="4839566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7428C22-9859-4F77-828B-B761B90E1460}"/>
              </a:ext>
            </a:extLst>
          </p:cNvPr>
          <p:cNvSpPr txBox="1"/>
          <p:nvPr/>
        </p:nvSpPr>
        <p:spPr>
          <a:xfrm>
            <a:off x="852256" y="5807232"/>
            <a:ext cx="1107045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800" b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l Figure 3. </a:t>
            </a:r>
            <a:r>
              <a:rPr lang="en-US" dirty="0">
                <a:latin typeface="Times New Roman" panose="02020603050405020304" pitchFamily="18" charset="0"/>
              </a:rPr>
              <a:t>Scree plot from principal components analysis in a sample of 494 Ethiopian women aged 15-49 years. </a:t>
            </a:r>
          </a:p>
        </p:txBody>
      </p:sp>
    </p:spTree>
    <p:extLst>
      <p:ext uri="{BB962C8B-B14F-4D97-AF65-F5344CB8AC3E}">
        <p14:creationId xmlns:p14="http://schemas.microsoft.com/office/powerpoint/2010/main" val="30344208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</TotalTime>
  <Words>22</Words>
  <Application>Microsoft Office PowerPoint</Application>
  <PresentationFormat>Widescreen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kele, Tesfaye Hailu</dc:creator>
  <cp:lastModifiedBy>rdserver1</cp:lastModifiedBy>
  <cp:revision>11</cp:revision>
  <dcterms:created xsi:type="dcterms:W3CDTF">2022-01-31T09:08:11Z</dcterms:created>
  <dcterms:modified xsi:type="dcterms:W3CDTF">2023-01-13T15:44:00Z</dcterms:modified>
</cp:coreProperties>
</file>